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5" d="100"/>
          <a:sy n="125" d="100"/>
        </p:scale>
        <p:origin x="32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E13B72-9AAA-4218-BB62-628C52FB42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D667B39-841C-42BC-BACA-1A0FB91252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7F6865-2009-4E63-B73C-4449CD828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3F0BED-F654-402F-B0FD-D7E98645F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CE3D84-43A7-44A8-94F5-205621B5F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8166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3D861C-29B2-4B68-91B7-293D75D16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974C35-E665-4612-8502-5378357E99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3CE504-2796-4E78-82F7-A856962EB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29ADDB-BE46-4A08-9F6F-F665D4EEB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99F1C1-9266-4808-9A19-E3FB29118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631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9A1ADCD-BB45-4848-8552-23258B989A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994BD30-6599-451F-B996-88A01611EB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9F783C-6272-4EDF-BD16-894A3B010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7C6553-ABBD-491F-89CB-F8E1BE215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3676EC-C307-4976-8C76-0BBF55E74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2779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2B14CC-F130-4693-8104-01534B168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2F787F4-34D3-42A8-B410-5D6EA9BDCE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EBA36F-AE16-412E-8DC9-28909A005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6D9D24-F68B-4972-8404-9278EEFD0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730129-D3CA-4B7E-B169-171B7E7B8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986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C82378-967E-4CBC-89F5-130677EB7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896363-288B-4466-9183-C43F79FB03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A0EE65-D3C3-414E-8372-80A476C01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180450-C7E9-47C1-89F3-5F6C4B3CF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F0AF00-9B22-4D1B-B425-542779500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301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FC4120-908E-4BBD-A0A9-A369AFF72F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180D1F5-4B1E-49E2-A599-EB08825D9E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BBE1A8D-BA4E-4FCC-B7DB-822F96A5B9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C04904-DD52-443E-9885-13DAD79EA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59E3CD-5E58-4D50-9EE3-09B2E40F4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1E1139-BD6A-453B-A4D6-3ED1114AE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210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AD5409-7047-422D-B6E6-79009CB1A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F94D48-5FA5-4C2D-BDA9-DA42DDDA5D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3C9D74B-D139-4844-AD3D-A3A65B2915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C5C139D-CCBD-48B2-8DA3-440EB79405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0A41C6F-D478-4E61-BF1B-2D44692731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E079620-15A4-451C-81EE-3766FAE7B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6A68C4B-0C3D-4DD1-A234-86F28724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85FFB7E-27DE-4A45-893F-D7E7A2398A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2115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A04B21-2A3B-4807-B917-5BF4E398E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EA88AE1-4AA3-4E2E-B394-3F063E833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C98F567-5358-41AE-A736-BC2F1DE41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BAB43A8-9C1B-4EA5-BF26-9C9021607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1785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44FEBD9-7F79-4A64-9C0E-ABB50BE5D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CAAA7D-250B-48ED-BC7E-4B8A821A7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DC4D5BD-9C5E-49CA-A928-2273E60A5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4233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975A79-236A-4152-A34B-63043B2930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428CE1-6264-4682-815C-75EF9924FE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FDA475-D80E-4B97-B75C-AACB95CEBE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670985-4EF6-4B34-96B0-D2034CFAD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B9228D-9F39-4AD7-AE8C-DBC4D380A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F2A2C29-AD65-4844-BE0A-7BB1074E5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193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31625F-D58B-4C8E-9EAC-42998AD27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BB19B64-CB1A-475C-8B3B-38E250140D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BF460A0-9732-48A3-A78E-7872E352A1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059F4F-5268-4616-8C28-724686971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34C088-9907-4C87-9F21-076C11136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6FF086-EA1B-475E-B4DC-372E1B15F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457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6D737B8-4F0C-4F1B-9B42-E8211EFE6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383AFF-AFB6-47A4-ABB4-1116046BDC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72841B-8D00-4B27-B138-4255476FEF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53B5D-51BB-4DC5-B817-BFA978D23E46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D8037D-9A87-4360-9383-E1C4C125AD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07CFAB-0428-4DF3-A091-48BD86EA7F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6C1C6-B57C-44BA-9181-7EF5E77E89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5108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oleObject" Target="../embeddings/oleObject13.bin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C2617B3A-B9C5-4A07-A816-3FAE06972075}"/>
              </a:ext>
            </a:extLst>
          </p:cNvPr>
          <p:cNvSpPr/>
          <p:nvPr/>
        </p:nvSpPr>
        <p:spPr>
          <a:xfrm>
            <a:off x="3616992" y="2766807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Baicale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D2AEFE6-DFDD-4A3C-9461-2788189139B7}"/>
              </a:ext>
            </a:extLst>
          </p:cNvPr>
          <p:cNvSpPr/>
          <p:nvPr/>
        </p:nvSpPr>
        <p:spPr>
          <a:xfrm>
            <a:off x="3586291" y="6425949"/>
            <a:ext cx="779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pigen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EB5BB588-3B36-4442-A156-BD14ACAFBB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2734910"/>
              </p:ext>
            </p:extLst>
          </p:nvPr>
        </p:nvGraphicFramePr>
        <p:xfrm>
          <a:off x="4735697" y="446645"/>
          <a:ext cx="1371586" cy="874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4" name="CS ChemDraw Drawing" r:id="rId3" imgW="2867804" imgH="1827094" progId="ChemDraw.Document.6.0">
                  <p:embed/>
                </p:oleObj>
              </mc:Choice>
              <mc:Fallback>
                <p:oleObj name="CS ChemDraw Drawing" r:id="rId3" imgW="2867804" imgH="1827094" progId="ChemDraw.Document.6.0">
                  <p:embed/>
                  <p:pic>
                    <p:nvPicPr>
                      <p:cNvPr id="154" name="对象 15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35697" y="446645"/>
                        <a:ext cx="1371586" cy="874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074B5B54-13E5-47D4-9023-46E12E2AB5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7110418"/>
              </p:ext>
            </p:extLst>
          </p:nvPr>
        </p:nvGraphicFramePr>
        <p:xfrm>
          <a:off x="3087164" y="5421556"/>
          <a:ext cx="1756797" cy="9810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5" name="CS ChemDraw Drawing" r:id="rId5" imgW="3368903" imgH="1880448" progId="ChemDraw.Document.6.0">
                  <p:embed/>
                </p:oleObj>
              </mc:Choice>
              <mc:Fallback>
                <p:oleObj name="CS ChemDraw Drawing" r:id="rId5" imgW="3368903" imgH="1880448" progId="ChemDraw.Document.6.0">
                  <p:embed/>
                  <p:pic>
                    <p:nvPicPr>
                      <p:cNvPr id="155" name="对象 15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87164" y="5421556"/>
                        <a:ext cx="1756797" cy="9810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CFF19577-50CA-428F-AEF7-D12ADC6C69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6740110"/>
              </p:ext>
            </p:extLst>
          </p:nvPr>
        </p:nvGraphicFramePr>
        <p:xfrm>
          <a:off x="5402813" y="3533569"/>
          <a:ext cx="1948747" cy="902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" name="CS ChemDraw Drawing" r:id="rId7" imgW="3945531" imgH="1826710" progId="ChemDraw.Document.6.0">
                  <p:embed/>
                </p:oleObj>
              </mc:Choice>
              <mc:Fallback>
                <p:oleObj name="CS ChemDraw Drawing" r:id="rId7" imgW="3945531" imgH="1826710" progId="ChemDraw.Document.6.0">
                  <p:embed/>
                  <p:pic>
                    <p:nvPicPr>
                      <p:cNvPr id="151" name="对象 15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402813" y="3533569"/>
                        <a:ext cx="1948747" cy="902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16145BAC-55AA-40C7-AA73-F803637DAD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9508578"/>
              </p:ext>
            </p:extLst>
          </p:nvPr>
        </p:nvGraphicFramePr>
        <p:xfrm>
          <a:off x="2813781" y="3477791"/>
          <a:ext cx="2060147" cy="9542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" name="CS ChemDraw Drawing" r:id="rId9" imgW="3945531" imgH="1826710" progId="ChemDraw.Document.6.0">
                  <p:embed/>
                </p:oleObj>
              </mc:Choice>
              <mc:Fallback>
                <p:oleObj name="CS ChemDraw Drawing" r:id="rId9" imgW="3945531" imgH="1826710" progId="ChemDraw.Document.6.0">
                  <p:embed/>
                  <p:pic>
                    <p:nvPicPr>
                      <p:cNvPr id="156" name="对象 15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13781" y="3477791"/>
                        <a:ext cx="2060147" cy="9542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16948A8B-79A0-4941-8C4D-72ADAB3FF0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5267287"/>
              </p:ext>
            </p:extLst>
          </p:nvPr>
        </p:nvGraphicFramePr>
        <p:xfrm>
          <a:off x="7485117" y="5468427"/>
          <a:ext cx="2265219" cy="9575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" name="CS ChemDraw Drawing" r:id="rId11" imgW="4446629" imgH="1880064" progId="ChemDraw.Document.6.0">
                  <p:embed/>
                </p:oleObj>
              </mc:Choice>
              <mc:Fallback>
                <p:oleObj name="CS ChemDraw Drawing" r:id="rId11" imgW="4446629" imgH="1880064" progId="ChemDraw.Document.6.0">
                  <p:embed/>
                  <p:pic>
                    <p:nvPicPr>
                      <p:cNvPr id="157" name="对象 156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485117" y="5468427"/>
                        <a:ext cx="2265219" cy="9575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3ED81796-459E-4AB5-B85B-2F96551A91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4508384"/>
              </p:ext>
            </p:extLst>
          </p:nvPr>
        </p:nvGraphicFramePr>
        <p:xfrm>
          <a:off x="5276460" y="5370323"/>
          <a:ext cx="1776159" cy="991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" name="CS ChemDraw Drawing" r:id="rId13" imgW="3369286" imgH="1880064" progId="ChemDraw.Document.6.0">
                  <p:embed/>
                </p:oleObj>
              </mc:Choice>
              <mc:Fallback>
                <p:oleObj name="CS ChemDraw Drawing" r:id="rId13" imgW="3369286" imgH="1880064" progId="ChemDraw.Document.6.0">
                  <p:embed/>
                  <p:pic>
                    <p:nvPicPr>
                      <p:cNvPr id="159" name="对象 15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76460" y="5370323"/>
                        <a:ext cx="1776159" cy="991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0F170FFB-026C-4275-8D62-5B577E94BF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5798401"/>
              </p:ext>
            </p:extLst>
          </p:nvPr>
        </p:nvGraphicFramePr>
        <p:xfrm>
          <a:off x="3234198" y="1890276"/>
          <a:ext cx="1437568" cy="9161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" name="CS ChemDraw Drawing" r:id="rId15" imgW="2866270" imgH="1826710" progId="ChemDraw.Document.6.0">
                  <p:embed/>
                </p:oleObj>
              </mc:Choice>
              <mc:Fallback>
                <p:oleObj name="CS ChemDraw Drawing" r:id="rId15" imgW="2866270" imgH="1826710" progId="ChemDraw.Document.6.0">
                  <p:embed/>
                  <p:pic>
                    <p:nvPicPr>
                      <p:cNvPr id="160" name="对象 159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234198" y="1890276"/>
                        <a:ext cx="1437568" cy="9161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27B3D48A-EEDF-47A6-93C7-C44F712001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7233932"/>
              </p:ext>
            </p:extLst>
          </p:nvPr>
        </p:nvGraphicFramePr>
        <p:xfrm>
          <a:off x="5758847" y="1916228"/>
          <a:ext cx="1484243" cy="945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" name="CS ChemDraw Drawing" r:id="rId17" imgW="2866270" imgH="1826710" progId="ChemDraw.Document.6.0">
                  <p:embed/>
                </p:oleObj>
              </mc:Choice>
              <mc:Fallback>
                <p:oleObj name="CS ChemDraw Drawing" r:id="rId17" imgW="2866270" imgH="1826710" progId="ChemDraw.Document.6.0">
                  <p:embed/>
                  <p:pic>
                    <p:nvPicPr>
                      <p:cNvPr id="161" name="对象 160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758847" y="1916228"/>
                        <a:ext cx="1484243" cy="945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81056BEC-DDA3-4471-B40D-61431ACB96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1651058"/>
              </p:ext>
            </p:extLst>
          </p:nvPr>
        </p:nvGraphicFramePr>
        <p:xfrm>
          <a:off x="8024125" y="1890276"/>
          <a:ext cx="1592654" cy="10150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2" name="CS ChemDraw Drawing" r:id="rId19" imgW="2866270" imgH="1826710" progId="ChemDraw.Document.6.0">
                  <p:embed/>
                </p:oleObj>
              </mc:Choice>
              <mc:Fallback>
                <p:oleObj name="CS ChemDraw Drawing" r:id="rId19" imgW="2866270" imgH="1826710" progId="ChemDraw.Document.6.0">
                  <p:embed/>
                  <p:pic>
                    <p:nvPicPr>
                      <p:cNvPr id="162" name="对象 161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024125" y="1890276"/>
                        <a:ext cx="1592654" cy="10150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DC41CA68-23AA-40F0-8791-E205898C22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3472556"/>
              </p:ext>
            </p:extLst>
          </p:nvPr>
        </p:nvGraphicFramePr>
        <p:xfrm>
          <a:off x="7779861" y="3568855"/>
          <a:ext cx="1970475" cy="8943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3" name="CS ChemDraw Drawing" r:id="rId21" imgW="4026044" imgH="1826710" progId="ChemDraw.Document.6.0">
                  <p:embed/>
                </p:oleObj>
              </mc:Choice>
              <mc:Fallback>
                <p:oleObj name="CS ChemDraw Drawing" r:id="rId21" imgW="4026044" imgH="1826710" progId="ChemDraw.Document.6.0">
                  <p:embed/>
                  <p:pic>
                    <p:nvPicPr>
                      <p:cNvPr id="163" name="对象 162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7779861" y="3568855"/>
                        <a:ext cx="1970475" cy="8943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E96E0755-25B8-4B25-A20D-A9305C6B9293}"/>
              </a:ext>
            </a:extLst>
          </p:cNvPr>
          <p:cNvCxnSpPr/>
          <p:nvPr/>
        </p:nvCxnSpPr>
        <p:spPr>
          <a:xfrm flipH="1">
            <a:off x="4142870" y="1346935"/>
            <a:ext cx="500236" cy="492108"/>
          </a:xfrm>
          <a:prstGeom prst="line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012FE53-7AA9-43E4-BB9D-C38EEC3BB3F9}"/>
              </a:ext>
            </a:extLst>
          </p:cNvPr>
          <p:cNvCxnSpPr/>
          <p:nvPr/>
        </p:nvCxnSpPr>
        <p:spPr>
          <a:xfrm>
            <a:off x="7351560" y="2455804"/>
            <a:ext cx="722286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2D284977-ECF4-43B0-95B5-325F5AF8E1B8}"/>
              </a:ext>
            </a:extLst>
          </p:cNvPr>
          <p:cNvCxnSpPr/>
          <p:nvPr/>
        </p:nvCxnSpPr>
        <p:spPr>
          <a:xfrm>
            <a:off x="5903223" y="1374956"/>
            <a:ext cx="473963" cy="442673"/>
          </a:xfrm>
          <a:prstGeom prst="line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09298CDA-4DA2-4C59-8415-EF6EFE62B0D7}"/>
              </a:ext>
            </a:extLst>
          </p:cNvPr>
          <p:cNvCxnSpPr/>
          <p:nvPr/>
        </p:nvCxnSpPr>
        <p:spPr>
          <a:xfrm>
            <a:off x="8971034" y="3133880"/>
            <a:ext cx="0" cy="434975"/>
          </a:xfrm>
          <a:prstGeom prst="line">
            <a:avLst/>
          </a:prstGeom>
          <a:ln w="28575">
            <a:solidFill>
              <a:schemeClr val="tx1"/>
            </a:solidFill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88A4BB7D-4C46-4C2E-94C4-7E6192CD928D}"/>
              </a:ext>
            </a:extLst>
          </p:cNvPr>
          <p:cNvCxnSpPr/>
          <p:nvPr/>
        </p:nvCxnSpPr>
        <p:spPr>
          <a:xfrm>
            <a:off x="6526609" y="3110961"/>
            <a:ext cx="0" cy="434975"/>
          </a:xfrm>
          <a:prstGeom prst="line">
            <a:avLst/>
          </a:prstGeom>
          <a:ln w="28575">
            <a:solidFill>
              <a:schemeClr val="tx1"/>
            </a:solidFill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304D603C-5369-4E73-98A9-9E293A6B8D37}"/>
              </a:ext>
            </a:extLst>
          </p:cNvPr>
          <p:cNvCxnSpPr/>
          <p:nvPr/>
        </p:nvCxnSpPr>
        <p:spPr>
          <a:xfrm>
            <a:off x="3952982" y="3124903"/>
            <a:ext cx="0" cy="434975"/>
          </a:xfrm>
          <a:prstGeom prst="line">
            <a:avLst/>
          </a:prstGeom>
          <a:ln w="28575">
            <a:solidFill>
              <a:schemeClr val="tx1"/>
            </a:solidFill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85FC5B67-8E5E-47B7-816A-F15D1CF0ABEC}"/>
              </a:ext>
            </a:extLst>
          </p:cNvPr>
          <p:cNvCxnSpPr/>
          <p:nvPr/>
        </p:nvCxnSpPr>
        <p:spPr>
          <a:xfrm rot="16200000">
            <a:off x="4837323" y="5808668"/>
            <a:ext cx="0" cy="434975"/>
          </a:xfrm>
          <a:prstGeom prst="line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BC1F036D-EF41-4C3E-9AB7-2609716F6D3F}"/>
              </a:ext>
            </a:extLst>
          </p:cNvPr>
          <p:cNvCxnSpPr/>
          <p:nvPr/>
        </p:nvCxnSpPr>
        <p:spPr>
          <a:xfrm rot="16200000">
            <a:off x="6935494" y="5843616"/>
            <a:ext cx="0" cy="434975"/>
          </a:xfrm>
          <a:prstGeom prst="line">
            <a:avLst/>
          </a:prstGeom>
          <a:ln w="28575">
            <a:solidFill>
              <a:schemeClr val="tx1"/>
            </a:solidFill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DE64054D-F3A5-43A3-A676-7C3D6D57FC8D}"/>
              </a:ext>
            </a:extLst>
          </p:cNvPr>
          <p:cNvSpPr txBox="1"/>
          <p:nvPr/>
        </p:nvSpPr>
        <p:spPr>
          <a:xfrm>
            <a:off x="2533206" y="314034"/>
            <a:ext cx="2621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  Chrysin as substrate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22CD4B7-0355-44EC-8FCA-3767A508908E}"/>
              </a:ext>
            </a:extLst>
          </p:cNvPr>
          <p:cNvSpPr txBox="1"/>
          <p:nvPr/>
        </p:nvSpPr>
        <p:spPr>
          <a:xfrm>
            <a:off x="2533206" y="5016146"/>
            <a:ext cx="2736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  Apigenin as substrate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70B0E80B-CFA5-41B2-A773-407AFA1715A3}"/>
              </a:ext>
            </a:extLst>
          </p:cNvPr>
          <p:cNvSpPr/>
          <p:nvPr/>
        </p:nvSpPr>
        <p:spPr>
          <a:xfrm>
            <a:off x="3886897" y="1309696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6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F00A9366-ED00-4D5E-9508-AD790628B4C5}"/>
              </a:ext>
            </a:extLst>
          </p:cNvPr>
          <p:cNvSpPr/>
          <p:nvPr/>
        </p:nvSpPr>
        <p:spPr>
          <a:xfrm>
            <a:off x="6113459" y="1351310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8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5BBF2DBB-AAE9-4E08-B267-0F175E2CE527}"/>
              </a:ext>
            </a:extLst>
          </p:cNvPr>
          <p:cNvSpPr/>
          <p:nvPr/>
        </p:nvSpPr>
        <p:spPr>
          <a:xfrm>
            <a:off x="7336116" y="2178805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8OM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712CACAA-3D2C-47F5-9655-E53BE8BFB3AA}"/>
              </a:ext>
            </a:extLst>
          </p:cNvPr>
          <p:cNvSpPr/>
          <p:nvPr/>
        </p:nvSpPr>
        <p:spPr>
          <a:xfrm>
            <a:off x="4608434" y="6082301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6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D4800F66-87C2-41DD-95D7-51AD7251CCF4}"/>
              </a:ext>
            </a:extLst>
          </p:cNvPr>
          <p:cNvSpPr/>
          <p:nvPr/>
        </p:nvSpPr>
        <p:spPr>
          <a:xfrm>
            <a:off x="6026312" y="2806466"/>
            <a:ext cx="104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orwogon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56803612-6E4F-40D2-8F0A-6D79C9841E6E}"/>
              </a:ext>
            </a:extLst>
          </p:cNvPr>
          <p:cNvSpPr/>
          <p:nvPr/>
        </p:nvSpPr>
        <p:spPr>
          <a:xfrm>
            <a:off x="8545862" y="2833962"/>
            <a:ext cx="829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Wogon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4AD3BCB1-4DD8-4682-A526-1EC1D3206F2B}"/>
              </a:ext>
            </a:extLst>
          </p:cNvPr>
          <p:cNvSpPr/>
          <p:nvPr/>
        </p:nvSpPr>
        <p:spPr>
          <a:xfrm>
            <a:off x="5587092" y="6425949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cutellare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53B06CEB-7C74-4B5D-B8DF-5A337B751375}"/>
              </a:ext>
            </a:extLst>
          </p:cNvPr>
          <p:cNvSpPr/>
          <p:nvPr/>
        </p:nvSpPr>
        <p:spPr>
          <a:xfrm>
            <a:off x="8180940" y="6421458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cutellar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E6FFFB15-BF21-401B-B85B-83B515C1F874}"/>
              </a:ext>
            </a:extLst>
          </p:cNvPr>
          <p:cNvSpPr/>
          <p:nvPr/>
        </p:nvSpPr>
        <p:spPr>
          <a:xfrm>
            <a:off x="3584753" y="4432009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Baica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2AEDB5CF-730D-496F-BE86-2F3719CB753A}"/>
              </a:ext>
            </a:extLst>
          </p:cNvPr>
          <p:cNvSpPr/>
          <p:nvPr/>
        </p:nvSpPr>
        <p:spPr>
          <a:xfrm>
            <a:off x="8545862" y="4431857"/>
            <a:ext cx="1033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Wogonosid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06AF4A3B-68AD-4091-BD6F-C4AE880F4F35}"/>
              </a:ext>
            </a:extLst>
          </p:cNvPr>
          <p:cNvSpPr/>
          <p:nvPr/>
        </p:nvSpPr>
        <p:spPr>
          <a:xfrm>
            <a:off x="6098994" y="4435462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orwogoside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对象 36">
            <a:extLst>
              <a:ext uri="{FF2B5EF4-FFF2-40B4-BE49-F238E27FC236}">
                <a16:creationId xmlns:a16="http://schemas.microsoft.com/office/drawing/2014/main" id="{72910730-1510-46E3-98AE-EFA6D5F2C1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9987766"/>
              </p:ext>
            </p:extLst>
          </p:nvPr>
        </p:nvGraphicFramePr>
        <p:xfrm>
          <a:off x="3188172" y="3884377"/>
          <a:ext cx="209073" cy="216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4" name="CS ChemDraw Drawing" r:id="rId23" imgW="368444" imgH="380389" progId="ChemDraw.Document.6.0">
                  <p:embed/>
                </p:oleObj>
              </mc:Choice>
              <mc:Fallback>
                <p:oleObj name="CS ChemDraw Drawing" r:id="rId23" imgW="368444" imgH="380389" progId="ChemDraw.Document.6.0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188172" y="3884377"/>
                        <a:ext cx="209073" cy="216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对象 37">
            <a:extLst>
              <a:ext uri="{FF2B5EF4-FFF2-40B4-BE49-F238E27FC236}">
                <a16:creationId xmlns:a16="http://schemas.microsoft.com/office/drawing/2014/main" id="{2404BCF8-E3DB-403F-A740-3C12F6D4C9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949635"/>
              </p:ext>
            </p:extLst>
          </p:nvPr>
        </p:nvGraphicFramePr>
        <p:xfrm>
          <a:off x="5743610" y="3922271"/>
          <a:ext cx="209073" cy="216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5" name="CS ChemDraw Drawing" r:id="rId25" imgW="368444" imgH="380389" progId="ChemDraw.Document.6.0">
                  <p:embed/>
                </p:oleObj>
              </mc:Choice>
              <mc:Fallback>
                <p:oleObj name="CS ChemDraw Drawing" r:id="rId25" imgW="368444" imgH="380389" progId="ChemDraw.Document.6.0">
                  <p:embed/>
                  <p:pic>
                    <p:nvPicPr>
                      <p:cNvPr id="36" name="对象 35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743610" y="3922271"/>
                        <a:ext cx="209073" cy="216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对象 38">
            <a:extLst>
              <a:ext uri="{FF2B5EF4-FFF2-40B4-BE49-F238E27FC236}">
                <a16:creationId xmlns:a16="http://schemas.microsoft.com/office/drawing/2014/main" id="{5DF0FC46-22E7-43C9-891E-EF2791A97B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1553861"/>
              </p:ext>
            </p:extLst>
          </p:nvPr>
        </p:nvGraphicFramePr>
        <p:xfrm>
          <a:off x="8110200" y="3946446"/>
          <a:ext cx="209073" cy="216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6" name="CS ChemDraw Drawing" r:id="rId26" imgW="368444" imgH="380389" progId="ChemDraw.Document.6.0">
                  <p:embed/>
                </p:oleObj>
              </mc:Choice>
              <mc:Fallback>
                <p:oleObj name="CS ChemDraw Drawing" r:id="rId26" imgW="368444" imgH="380389" progId="ChemDraw.Document.6.0">
                  <p:embed/>
                  <p:pic>
                    <p:nvPicPr>
                      <p:cNvPr id="37" name="对象 36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110200" y="3946446"/>
                        <a:ext cx="209073" cy="216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对象 39">
            <a:extLst>
              <a:ext uri="{FF2B5EF4-FFF2-40B4-BE49-F238E27FC236}">
                <a16:creationId xmlns:a16="http://schemas.microsoft.com/office/drawing/2014/main" id="{8964BA7D-2CC3-4837-9E23-2001962EE6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0568053"/>
              </p:ext>
            </p:extLst>
          </p:nvPr>
        </p:nvGraphicFramePr>
        <p:xfrm>
          <a:off x="7843064" y="5894204"/>
          <a:ext cx="209073" cy="216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7" name="CS ChemDraw Drawing" r:id="rId27" imgW="368444" imgH="380389" progId="ChemDraw.Document.6.0">
                  <p:embed/>
                </p:oleObj>
              </mc:Choice>
              <mc:Fallback>
                <p:oleObj name="CS ChemDraw Drawing" r:id="rId27" imgW="368444" imgH="380389" progId="ChemDraw.Document.6.0">
                  <p:embed/>
                  <p:pic>
                    <p:nvPicPr>
                      <p:cNvPr id="38" name="对象 37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7843064" y="5894204"/>
                        <a:ext cx="209073" cy="216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矩形 40">
            <a:extLst>
              <a:ext uri="{FF2B5EF4-FFF2-40B4-BE49-F238E27FC236}">
                <a16:creationId xmlns:a16="http://schemas.microsoft.com/office/drawing/2014/main" id="{53E8B589-8E1F-4E03-A0C9-F03BF75E2B89}"/>
              </a:ext>
            </a:extLst>
          </p:cNvPr>
          <p:cNvSpPr/>
          <p:nvPr/>
        </p:nvSpPr>
        <p:spPr>
          <a:xfrm>
            <a:off x="8956593" y="3141897"/>
            <a:ext cx="601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G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C58515C6-BF3C-4B85-8D89-8899AFAD8F47}"/>
              </a:ext>
            </a:extLst>
          </p:cNvPr>
          <p:cNvSpPr/>
          <p:nvPr/>
        </p:nvSpPr>
        <p:spPr>
          <a:xfrm>
            <a:off x="6565839" y="3147479"/>
            <a:ext cx="601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G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18DAA3FA-209E-4934-83B6-3DFA5FA49317}"/>
              </a:ext>
            </a:extLst>
          </p:cNvPr>
          <p:cNvSpPr/>
          <p:nvPr/>
        </p:nvSpPr>
        <p:spPr>
          <a:xfrm>
            <a:off x="3932742" y="3156047"/>
            <a:ext cx="601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G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410D7286-9338-4323-9C03-BA83AE86C3CD}"/>
              </a:ext>
            </a:extLst>
          </p:cNvPr>
          <p:cNvSpPr/>
          <p:nvPr/>
        </p:nvSpPr>
        <p:spPr>
          <a:xfrm>
            <a:off x="6591309" y="6150041"/>
            <a:ext cx="601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G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0D2B7E8A-204D-4578-AE92-E8AD752E2330}"/>
              </a:ext>
            </a:extLst>
          </p:cNvPr>
          <p:cNvSpPr/>
          <p:nvPr/>
        </p:nvSpPr>
        <p:spPr>
          <a:xfrm>
            <a:off x="5033194" y="1319293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hrys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313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26</Words>
  <Application>Microsoft Office PowerPoint</Application>
  <PresentationFormat>宽屏</PresentationFormat>
  <Paragraphs>20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CS ChemDraw Drawing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5</cp:revision>
  <dcterms:created xsi:type="dcterms:W3CDTF">2020-02-20T13:21:43Z</dcterms:created>
  <dcterms:modified xsi:type="dcterms:W3CDTF">2020-10-24T07:24:44Z</dcterms:modified>
</cp:coreProperties>
</file>